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 horzBarState="maximized">
    <p:restoredLeft sz="14995" autoAdjust="0"/>
    <p:restoredTop sz="94660"/>
  </p:normalViewPr>
  <p:slideViewPr>
    <p:cSldViewPr snapToGrid="0">
      <p:cViewPr varScale="1">
        <p:scale>
          <a:sx n="50" d="100"/>
          <a:sy n="50" d="100"/>
        </p:scale>
        <p:origin x="-2376" y="-11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616550-1BD4-4EF6-B0E2-272BAF719C33}" type="datetimeFigureOut">
              <a:rPr lang="zh-CN" altLang="en-US" smtClean="0"/>
              <a:pPr/>
              <a:t>2022/3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DE3446-9B61-40F4-9111-3975884B90D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1651469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616550-1BD4-4EF6-B0E2-272BAF719C33}" type="datetimeFigureOut">
              <a:rPr lang="zh-CN" altLang="en-US" smtClean="0"/>
              <a:pPr/>
              <a:t>2022/3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DE3446-9B61-40F4-9111-3975884B90D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5863660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616550-1BD4-4EF6-B0E2-272BAF719C33}" type="datetimeFigureOut">
              <a:rPr lang="zh-CN" altLang="en-US" smtClean="0"/>
              <a:pPr/>
              <a:t>2022/3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DE3446-9B61-40F4-9111-3975884B90D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1273505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616550-1BD4-4EF6-B0E2-272BAF719C33}" type="datetimeFigureOut">
              <a:rPr lang="zh-CN" altLang="en-US" smtClean="0"/>
              <a:pPr/>
              <a:t>2022/3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DE3446-9B61-40F4-9111-3975884B90D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2770441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616550-1BD4-4EF6-B0E2-272BAF719C33}" type="datetimeFigureOut">
              <a:rPr lang="zh-CN" altLang="en-US" smtClean="0"/>
              <a:pPr/>
              <a:t>2022/3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DE3446-9B61-40F4-9111-3975884B90D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509781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616550-1BD4-4EF6-B0E2-272BAF719C33}" type="datetimeFigureOut">
              <a:rPr lang="zh-CN" altLang="en-US" smtClean="0"/>
              <a:pPr/>
              <a:t>2022/3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DE3446-9B61-40F4-9111-3975884B90D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3476288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616550-1BD4-4EF6-B0E2-272BAF719C33}" type="datetimeFigureOut">
              <a:rPr lang="zh-CN" altLang="en-US" smtClean="0"/>
              <a:pPr/>
              <a:t>2022/3/2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DE3446-9B61-40F4-9111-3975884B90D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4339993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616550-1BD4-4EF6-B0E2-272BAF719C33}" type="datetimeFigureOut">
              <a:rPr lang="zh-CN" altLang="en-US" smtClean="0"/>
              <a:pPr/>
              <a:t>2022/3/2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DE3446-9B61-40F4-9111-3975884B90D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7870188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616550-1BD4-4EF6-B0E2-272BAF719C33}" type="datetimeFigureOut">
              <a:rPr lang="zh-CN" altLang="en-US" smtClean="0"/>
              <a:pPr/>
              <a:t>2022/3/2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DE3446-9B61-40F4-9111-3975884B90D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7082269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616550-1BD4-4EF6-B0E2-272BAF719C33}" type="datetimeFigureOut">
              <a:rPr lang="zh-CN" altLang="en-US" smtClean="0"/>
              <a:pPr/>
              <a:t>2022/3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DE3446-9B61-40F4-9111-3975884B90D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5631709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616550-1BD4-4EF6-B0E2-272BAF719C33}" type="datetimeFigureOut">
              <a:rPr lang="zh-CN" altLang="en-US" smtClean="0"/>
              <a:pPr/>
              <a:t>2022/3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DE3446-9B61-40F4-9111-3975884B90D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4592546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616550-1BD4-4EF6-B0E2-272BAF719C33}" type="datetimeFigureOut">
              <a:rPr lang="zh-CN" altLang="en-US" smtClean="0"/>
              <a:pPr/>
              <a:t>2022/3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DE3446-9B61-40F4-9111-3975884B90D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9991955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矩形 4">
            <a:extLst>
              <a:ext uri="{FF2B5EF4-FFF2-40B4-BE49-F238E27FC236}">
                <a16:creationId xmlns:a16="http://schemas.microsoft.com/office/drawing/2014/main" xmlns="" id="{89D89BD6-8C7D-4D27-9819-21C4728A0ACC}"/>
              </a:ext>
            </a:extLst>
          </p:cNvPr>
          <p:cNvSpPr/>
          <p:nvPr/>
        </p:nvSpPr>
        <p:spPr>
          <a:xfrm>
            <a:off x="433316" y="345000"/>
            <a:ext cx="5991367" cy="92160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321" name="组合 320">
            <a:extLst>
              <a:ext uri="{FF2B5EF4-FFF2-40B4-BE49-F238E27FC236}">
                <a16:creationId xmlns:a16="http://schemas.microsoft.com/office/drawing/2014/main" xmlns="" id="{43102788-8883-46E7-9170-71E06B215489}"/>
              </a:ext>
            </a:extLst>
          </p:cNvPr>
          <p:cNvGrpSpPr/>
          <p:nvPr/>
        </p:nvGrpSpPr>
        <p:grpSpPr>
          <a:xfrm>
            <a:off x="621096" y="570555"/>
            <a:ext cx="5551366" cy="3853714"/>
            <a:chOff x="639234" y="4182525"/>
            <a:chExt cx="5551366" cy="3853714"/>
          </a:xfrm>
        </p:grpSpPr>
        <p:sp>
          <p:nvSpPr>
            <p:cNvPr id="322" name="文本框 321">
              <a:extLst>
                <a:ext uri="{FF2B5EF4-FFF2-40B4-BE49-F238E27FC236}">
                  <a16:creationId xmlns:a16="http://schemas.microsoft.com/office/drawing/2014/main" xmlns="" id="{F6C8096A-9046-4F78-9E3C-FD212B6B4B07}"/>
                </a:ext>
              </a:extLst>
            </p:cNvPr>
            <p:cNvSpPr txBox="1"/>
            <p:nvPr/>
          </p:nvSpPr>
          <p:spPr>
            <a:xfrm>
              <a:off x="639234" y="4191171"/>
              <a:ext cx="165713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material 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323" name="组合 322">
              <a:extLst>
                <a:ext uri="{FF2B5EF4-FFF2-40B4-BE49-F238E27FC236}">
                  <a16:creationId xmlns:a16="http://schemas.microsoft.com/office/drawing/2014/main" xmlns="" id="{62032E70-2355-4A1B-9F92-F8CDE6A74069}"/>
                </a:ext>
              </a:extLst>
            </p:cNvPr>
            <p:cNvGrpSpPr/>
            <p:nvPr/>
          </p:nvGrpSpPr>
          <p:grpSpPr>
            <a:xfrm>
              <a:off x="667397" y="4182525"/>
              <a:ext cx="5523203" cy="3853714"/>
              <a:chOff x="433315" y="604677"/>
              <a:chExt cx="5523203" cy="3853714"/>
            </a:xfrm>
          </p:grpSpPr>
          <p:sp>
            <p:nvSpPr>
              <p:cNvPr id="324" name="文本框 323">
                <a:extLst>
                  <a:ext uri="{FF2B5EF4-FFF2-40B4-BE49-F238E27FC236}">
                    <a16:creationId xmlns:a16="http://schemas.microsoft.com/office/drawing/2014/main" xmlns="" id="{0ECEE3B7-73C6-4D0C-8F72-038D5275B168}"/>
                  </a:ext>
                </a:extLst>
              </p:cNvPr>
              <p:cNvSpPr txBox="1"/>
              <p:nvPr/>
            </p:nvSpPr>
            <p:spPr>
              <a:xfrm>
                <a:off x="3116766" y="604677"/>
                <a:ext cx="109859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op 30 of Enrichment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325" name="组合 324">
                <a:extLst>
                  <a:ext uri="{FF2B5EF4-FFF2-40B4-BE49-F238E27FC236}">
                    <a16:creationId xmlns:a16="http://schemas.microsoft.com/office/drawing/2014/main" xmlns="" id="{748BD951-0DBA-4344-9E1A-DBD2A5306237}"/>
                  </a:ext>
                </a:extLst>
              </p:cNvPr>
              <p:cNvGrpSpPr/>
              <p:nvPr/>
            </p:nvGrpSpPr>
            <p:grpSpPr>
              <a:xfrm>
                <a:off x="433315" y="663946"/>
                <a:ext cx="5523203" cy="3794445"/>
                <a:chOff x="433315" y="663946"/>
                <a:chExt cx="5523203" cy="3794445"/>
              </a:xfrm>
            </p:grpSpPr>
            <p:grpSp>
              <p:nvGrpSpPr>
                <p:cNvPr id="326" name="组合 325">
                  <a:extLst>
                    <a:ext uri="{FF2B5EF4-FFF2-40B4-BE49-F238E27FC236}">
                      <a16:creationId xmlns:a16="http://schemas.microsoft.com/office/drawing/2014/main" xmlns="" id="{608CCFB1-DC9E-41B6-A633-1135E333A3E6}"/>
                    </a:ext>
                  </a:extLst>
                </p:cNvPr>
                <p:cNvGrpSpPr/>
                <p:nvPr/>
              </p:nvGrpSpPr>
              <p:grpSpPr>
                <a:xfrm>
                  <a:off x="433315" y="820121"/>
                  <a:ext cx="4150373" cy="3422826"/>
                  <a:chOff x="433315" y="820121"/>
                  <a:chExt cx="4150373" cy="3422826"/>
                </a:xfrm>
              </p:grpSpPr>
              <p:pic>
                <p:nvPicPr>
                  <p:cNvPr id="358" name="图片 357">
                    <a:extLst>
                      <a:ext uri="{FF2B5EF4-FFF2-40B4-BE49-F238E27FC236}">
                        <a16:creationId xmlns:a16="http://schemas.microsoft.com/office/drawing/2014/main" xmlns="" id="{942EA9C8-4E66-4002-9738-0487460E0DE6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"/>
                  <a:stretch>
                    <a:fillRect/>
                  </a:stretch>
                </p:blipFill>
                <p:spPr>
                  <a:xfrm>
                    <a:off x="2748444" y="820121"/>
                    <a:ext cx="1835244" cy="3422826"/>
                  </a:xfrm>
                  <a:prstGeom prst="rect">
                    <a:avLst/>
                  </a:prstGeom>
                </p:spPr>
              </p:pic>
              <p:grpSp>
                <p:nvGrpSpPr>
                  <p:cNvPr id="359" name="组合 358">
                    <a:extLst>
                      <a:ext uri="{FF2B5EF4-FFF2-40B4-BE49-F238E27FC236}">
                        <a16:creationId xmlns:a16="http://schemas.microsoft.com/office/drawing/2014/main" xmlns="" id="{720E5F74-CA77-4518-BE54-DBE27C214696}"/>
                      </a:ext>
                    </a:extLst>
                  </p:cNvPr>
                  <p:cNvGrpSpPr/>
                  <p:nvPr/>
                </p:nvGrpSpPr>
                <p:grpSpPr>
                  <a:xfrm>
                    <a:off x="433315" y="879390"/>
                    <a:ext cx="2405818" cy="3294130"/>
                    <a:chOff x="433315" y="879390"/>
                    <a:chExt cx="2405818" cy="3294130"/>
                  </a:xfrm>
                </p:grpSpPr>
                <p:grpSp>
                  <p:nvGrpSpPr>
                    <p:cNvPr id="360" name="组合 359">
                      <a:extLst>
                        <a:ext uri="{FF2B5EF4-FFF2-40B4-BE49-F238E27FC236}">
                          <a16:creationId xmlns:a16="http://schemas.microsoft.com/office/drawing/2014/main" xmlns="" id="{E60940F9-76A3-4D2F-834E-9740E33EF322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433316" y="879390"/>
                      <a:ext cx="2405817" cy="1372176"/>
                      <a:chOff x="433316" y="879390"/>
                      <a:chExt cx="2405817" cy="1372176"/>
                    </a:xfrm>
                  </p:grpSpPr>
                  <p:sp>
                    <p:nvSpPr>
                      <p:cNvPr id="380" name="文本框 379">
                        <a:extLst>
                          <a:ext uri="{FF2B5EF4-FFF2-40B4-BE49-F238E27FC236}">
                            <a16:creationId xmlns:a16="http://schemas.microsoft.com/office/drawing/2014/main" xmlns="" id="{E989E011-35B9-497A-93C2-B8773D667FBA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22573" y="2036122"/>
                        <a:ext cx="2216560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altLang="zh-CN" sz="8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transmembrane receptor protein tyrosine kinase…</a:t>
                        </a:r>
                        <a:endParaRPr lang="zh-CN" alt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381" name="文本框 380">
                        <a:extLst>
                          <a:ext uri="{FF2B5EF4-FFF2-40B4-BE49-F238E27FC236}">
                            <a16:creationId xmlns:a16="http://schemas.microsoft.com/office/drawing/2014/main" xmlns="" id="{3394066A-2742-4C65-B2F1-E09CDA500D5A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22573" y="879390"/>
                        <a:ext cx="2216560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altLang="zh-CN" sz="8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cellular response to lipopolysaccharide</a:t>
                        </a:r>
                        <a:endParaRPr lang="zh-CN" alt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382" name="文本框 381">
                        <a:extLst>
                          <a:ext uri="{FF2B5EF4-FFF2-40B4-BE49-F238E27FC236}">
                            <a16:creationId xmlns:a16="http://schemas.microsoft.com/office/drawing/2014/main" xmlns="" id="{A75B1B29-D813-40A7-AFC3-9BB521E2D6D7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22573" y="984547"/>
                        <a:ext cx="2216560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altLang="zh-CN" sz="8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intracellular membrane-bounded organelle</a:t>
                        </a:r>
                        <a:endParaRPr lang="zh-CN" alt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383" name="文本框 382">
                        <a:extLst>
                          <a:ext uri="{FF2B5EF4-FFF2-40B4-BE49-F238E27FC236}">
                            <a16:creationId xmlns:a16="http://schemas.microsoft.com/office/drawing/2014/main" xmlns="" id="{97749DE7-ECBC-4341-9AF8-F92B6C66152F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22573" y="1089704"/>
                        <a:ext cx="2216560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altLang="zh-CN" sz="8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negative regulation of ruffle assembly</a:t>
                        </a:r>
                        <a:endParaRPr lang="zh-CN" alt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384" name="文本框 383">
                        <a:extLst>
                          <a:ext uri="{FF2B5EF4-FFF2-40B4-BE49-F238E27FC236}">
                            <a16:creationId xmlns:a16="http://schemas.microsoft.com/office/drawing/2014/main" xmlns="" id="{EB37C7CD-B83B-4995-AB37-B477D80FB60B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22573" y="1194861"/>
                        <a:ext cx="2216560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altLang="zh-CN" sz="8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negative regulation of phosphorylation</a:t>
                        </a:r>
                        <a:endParaRPr lang="zh-CN" alt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385" name="文本框 384">
                        <a:extLst>
                          <a:ext uri="{FF2B5EF4-FFF2-40B4-BE49-F238E27FC236}">
                            <a16:creationId xmlns:a16="http://schemas.microsoft.com/office/drawing/2014/main" xmlns="" id="{FF5E05E7-DFE6-4AD0-8D5C-A93580AC4B1D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22573" y="1300018"/>
                        <a:ext cx="2216560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altLang="zh-CN" sz="8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positive regulation of microglial cell activation</a:t>
                        </a:r>
                        <a:endParaRPr lang="zh-CN" alt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386" name="文本框 385">
                        <a:extLst>
                          <a:ext uri="{FF2B5EF4-FFF2-40B4-BE49-F238E27FC236}">
                            <a16:creationId xmlns:a16="http://schemas.microsoft.com/office/drawing/2014/main" xmlns="" id="{F8C62E42-79E7-4D73-BEBC-54F7A28CF68E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22573" y="1405175"/>
                        <a:ext cx="2216560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altLang="zh-CN" sz="8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lymphocyte chemotaxis</a:t>
                        </a:r>
                        <a:endParaRPr lang="zh-CN" alt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387" name="文本框 386">
                        <a:extLst>
                          <a:ext uri="{FF2B5EF4-FFF2-40B4-BE49-F238E27FC236}">
                            <a16:creationId xmlns:a16="http://schemas.microsoft.com/office/drawing/2014/main" xmlns="" id="{442300B5-765C-42D8-917F-2C332AD0A3CE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22573" y="1510332"/>
                        <a:ext cx="2216560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altLang="zh-CN" sz="8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endocytic vesicle lumen</a:t>
                        </a:r>
                        <a:endParaRPr lang="zh-CN" alt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388" name="文本框 387">
                        <a:extLst>
                          <a:ext uri="{FF2B5EF4-FFF2-40B4-BE49-F238E27FC236}">
                            <a16:creationId xmlns:a16="http://schemas.microsoft.com/office/drawing/2014/main" xmlns="" id="{ECCCA8B8-7079-453D-B482-471F507530D2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22573" y="1615489"/>
                        <a:ext cx="2216560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altLang="zh-CN" sz="8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positive regulation of B cell receptor signalin…</a:t>
                        </a:r>
                        <a:endParaRPr lang="zh-CN" alt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389" name="文本框 388">
                        <a:extLst>
                          <a:ext uri="{FF2B5EF4-FFF2-40B4-BE49-F238E27FC236}">
                            <a16:creationId xmlns:a16="http://schemas.microsoft.com/office/drawing/2014/main" xmlns="" id="{22BE59F2-F4C9-4168-9142-4D343C4BD26F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22573" y="1720646"/>
                        <a:ext cx="2216560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altLang="zh-CN" sz="8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angiotensin maturation</a:t>
                        </a:r>
                        <a:endParaRPr lang="zh-CN" alt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390" name="文本框 389">
                        <a:extLst>
                          <a:ext uri="{FF2B5EF4-FFF2-40B4-BE49-F238E27FC236}">
                            <a16:creationId xmlns:a16="http://schemas.microsoft.com/office/drawing/2014/main" xmlns="" id="{A1B504C7-E7E7-4F99-B59C-0AF4DE80F784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33316" y="1825803"/>
                        <a:ext cx="2405817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altLang="zh-CN" sz="8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epithelial tube branching involved in lung morp…</a:t>
                        </a:r>
                        <a:endParaRPr lang="zh-CN" alt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391" name="文本框 390">
                        <a:extLst>
                          <a:ext uri="{FF2B5EF4-FFF2-40B4-BE49-F238E27FC236}">
                            <a16:creationId xmlns:a16="http://schemas.microsoft.com/office/drawing/2014/main" xmlns="" id="{7FECA969-45E6-4AE3-B9C3-CFC67161CC55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33316" y="1930960"/>
                        <a:ext cx="2405817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altLang="zh-CN" sz="8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cell cortex region</a:t>
                        </a:r>
                        <a:endParaRPr lang="zh-CN" alt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</p:grpSp>
                <p:grpSp>
                  <p:nvGrpSpPr>
                    <p:cNvPr id="361" name="组合 360">
                      <a:extLst>
                        <a:ext uri="{FF2B5EF4-FFF2-40B4-BE49-F238E27FC236}">
                          <a16:creationId xmlns:a16="http://schemas.microsoft.com/office/drawing/2014/main" xmlns="" id="{6FAE7229-58DD-427D-9444-234DDCCBB273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433315" y="2145059"/>
                      <a:ext cx="2405817" cy="2028461"/>
                      <a:chOff x="433315" y="2145059"/>
                      <a:chExt cx="2405817" cy="2028461"/>
                    </a:xfrm>
                  </p:grpSpPr>
                  <p:sp>
                    <p:nvSpPr>
                      <p:cNvPr id="362" name="文本框 361">
                        <a:extLst>
                          <a:ext uri="{FF2B5EF4-FFF2-40B4-BE49-F238E27FC236}">
                            <a16:creationId xmlns:a16="http://schemas.microsoft.com/office/drawing/2014/main" xmlns="" id="{A9F4FBF5-605B-4A2A-89E0-C6FFD65267BC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33315" y="2145059"/>
                        <a:ext cx="2405817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altLang="zh-CN" sz="8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MyD88-independent toll-like receptor signaling</a:t>
                        </a:r>
                        <a:endParaRPr lang="zh-CN" alt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363" name="文本框 362">
                        <a:extLst>
                          <a:ext uri="{FF2B5EF4-FFF2-40B4-BE49-F238E27FC236}">
                            <a16:creationId xmlns:a16="http://schemas.microsoft.com/office/drawing/2014/main" xmlns="" id="{6DD52D33-AE88-4B06-86B7-526BA081FAF9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33315" y="2251707"/>
                        <a:ext cx="2405817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altLang="zh-CN" sz="8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positive regulation of actin cytoskeleton reorg… </a:t>
                        </a:r>
                        <a:endParaRPr lang="zh-CN" alt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364" name="文本框 363">
                        <a:extLst>
                          <a:ext uri="{FF2B5EF4-FFF2-40B4-BE49-F238E27FC236}">
                            <a16:creationId xmlns:a16="http://schemas.microsoft.com/office/drawing/2014/main" xmlns="" id="{D0451B2A-FEEF-4601-A6B4-DE68F64D3A0B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33315" y="2358355"/>
                        <a:ext cx="2405817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altLang="zh-CN" sz="8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high-density lipoprotein particle </a:t>
                        </a:r>
                        <a:endParaRPr lang="zh-CN" alt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365" name="文本框 364">
                        <a:extLst>
                          <a:ext uri="{FF2B5EF4-FFF2-40B4-BE49-F238E27FC236}">
                            <a16:creationId xmlns:a16="http://schemas.microsoft.com/office/drawing/2014/main" xmlns="" id="{12E435D2-4F38-4C81-ACAD-231DE849119B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33315" y="2465003"/>
                        <a:ext cx="2405817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altLang="zh-CN" sz="8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toll-like receptor 4 signaling pathway</a:t>
                        </a:r>
                        <a:endParaRPr lang="zh-CN" alt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366" name="文本框 365">
                        <a:extLst>
                          <a:ext uri="{FF2B5EF4-FFF2-40B4-BE49-F238E27FC236}">
                            <a16:creationId xmlns:a16="http://schemas.microsoft.com/office/drawing/2014/main" xmlns="" id="{494C0604-D522-4BED-BC6D-D494BDA2F63F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33315" y="2571651"/>
                        <a:ext cx="2405817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altLang="zh-CN" sz="8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apicolateral plasma membrane</a:t>
                        </a:r>
                        <a:endParaRPr lang="zh-CN" alt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367" name="文本框 366">
                        <a:extLst>
                          <a:ext uri="{FF2B5EF4-FFF2-40B4-BE49-F238E27FC236}">
                            <a16:creationId xmlns:a16="http://schemas.microsoft.com/office/drawing/2014/main" xmlns="" id="{40ABFC07-14B2-4B82-88C8-3C5E330E52B0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33315" y="2678299"/>
                        <a:ext cx="2405817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altLang="zh-CN" sz="8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positive regulation of cytokine secretion</a:t>
                        </a:r>
                        <a:endParaRPr lang="zh-CN" alt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368" name="文本框 367">
                        <a:extLst>
                          <a:ext uri="{FF2B5EF4-FFF2-40B4-BE49-F238E27FC236}">
                            <a16:creationId xmlns:a16="http://schemas.microsoft.com/office/drawing/2014/main" xmlns="" id="{F8981322-ABCD-4890-A209-0B8C0D546506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33315" y="2784947"/>
                        <a:ext cx="2405817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altLang="zh-CN" sz="8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chemoattractant activity</a:t>
                        </a:r>
                        <a:endParaRPr lang="zh-CN" alt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369" name="文本框 368">
                        <a:extLst>
                          <a:ext uri="{FF2B5EF4-FFF2-40B4-BE49-F238E27FC236}">
                            <a16:creationId xmlns:a16="http://schemas.microsoft.com/office/drawing/2014/main" xmlns="" id="{9C88FA01-1F8D-4646-97C9-B9F365F1C03C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33315" y="2891595"/>
                        <a:ext cx="2405817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altLang="zh-CN" sz="8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cellular glucuronidation</a:t>
                        </a:r>
                        <a:endParaRPr lang="zh-CN" alt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370" name="文本框 369">
                        <a:extLst>
                          <a:ext uri="{FF2B5EF4-FFF2-40B4-BE49-F238E27FC236}">
                            <a16:creationId xmlns:a16="http://schemas.microsoft.com/office/drawing/2014/main" xmlns="" id="{C64B8BA1-E02E-41B6-A41D-8E95E1E3A296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33315" y="2998243"/>
                        <a:ext cx="2405817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altLang="zh-CN" sz="8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regulation of neuron death</a:t>
                        </a:r>
                        <a:endParaRPr lang="zh-CN" alt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371" name="文本框 370">
                        <a:extLst>
                          <a:ext uri="{FF2B5EF4-FFF2-40B4-BE49-F238E27FC236}">
                            <a16:creationId xmlns:a16="http://schemas.microsoft.com/office/drawing/2014/main" xmlns="" id="{A5F77391-B4A8-4AD3-87DF-ABEB53B5D1D9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33315" y="3104891"/>
                        <a:ext cx="2405817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altLang="zh-CN" sz="8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positive regulation of neural precursor cell pr…</a:t>
                        </a:r>
                        <a:endParaRPr lang="zh-CN" alt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372" name="文本框 371">
                        <a:extLst>
                          <a:ext uri="{FF2B5EF4-FFF2-40B4-BE49-F238E27FC236}">
                            <a16:creationId xmlns:a16="http://schemas.microsoft.com/office/drawing/2014/main" xmlns="" id="{03352E79-D8C5-4B92-9935-AA178907A69E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33315" y="3211539"/>
                        <a:ext cx="2405817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altLang="zh-CN" sz="8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regulation of protein secretion</a:t>
                        </a:r>
                        <a:endParaRPr lang="zh-CN" alt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373" name="文本框 372">
                        <a:extLst>
                          <a:ext uri="{FF2B5EF4-FFF2-40B4-BE49-F238E27FC236}">
                            <a16:creationId xmlns:a16="http://schemas.microsoft.com/office/drawing/2014/main" xmlns="" id="{FCF39D07-CF75-4E37-A41A-43BDEE3C1F1A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33315" y="3318187"/>
                        <a:ext cx="2405817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altLang="zh-CN" sz="8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carboxypeptidase activity</a:t>
                        </a:r>
                        <a:endParaRPr lang="zh-CN" alt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374" name="文本框 373">
                        <a:extLst>
                          <a:ext uri="{FF2B5EF4-FFF2-40B4-BE49-F238E27FC236}">
                            <a16:creationId xmlns:a16="http://schemas.microsoft.com/office/drawing/2014/main" xmlns="" id="{F68ED27E-FAFC-424C-8412-FD74A56914AD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33315" y="3424835"/>
                        <a:ext cx="2405817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altLang="zh-CN" sz="8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calcium-independent cell-cell adhesion via plas…</a:t>
                        </a:r>
                        <a:endParaRPr lang="zh-CN" alt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375" name="文本框 374">
                        <a:extLst>
                          <a:ext uri="{FF2B5EF4-FFF2-40B4-BE49-F238E27FC236}">
                            <a16:creationId xmlns:a16="http://schemas.microsoft.com/office/drawing/2014/main" xmlns="" id="{FE5FDD01-B8F4-4642-BD99-4CDD34A9B152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33315" y="3531483"/>
                        <a:ext cx="2405817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altLang="zh-CN" sz="8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steroid metabolic process</a:t>
                        </a:r>
                        <a:endParaRPr lang="zh-CN" alt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376" name="文本框 375">
                        <a:extLst>
                          <a:ext uri="{FF2B5EF4-FFF2-40B4-BE49-F238E27FC236}">
                            <a16:creationId xmlns:a16="http://schemas.microsoft.com/office/drawing/2014/main" xmlns="" id="{1093F6CA-B04D-4BBD-A204-BE01B32621BF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33315" y="3638131"/>
                        <a:ext cx="2405817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US" altLang="zh-CN" sz="8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COPII-coated ER to Golgi transport vesicle</a:t>
                        </a:r>
                        <a:endParaRPr lang="zh-CN" alt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377" name="文本框 35">
                        <a:extLst>
                          <a:ext uri="{FF2B5EF4-FFF2-40B4-BE49-F238E27FC236}">
                            <a16:creationId xmlns:a16="http://schemas.microsoft.com/office/drawing/2014/main" xmlns="" id="{95319D69-348F-4E8E-898C-34EB833ADBB5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33315" y="3744779"/>
                        <a:ext cx="2405817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>
                        <a:defPPr>
                          <a:defRPr lang="en-US"/>
                        </a:defPPr>
                        <a:lvl1pPr marL="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r"/>
                        <a:r>
                          <a:rPr lang="en-US" altLang="zh-CN" sz="8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protein kinase binding</a:t>
                        </a:r>
                        <a:endParaRPr lang="zh-CN" alt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378" name="文本框 35">
                        <a:extLst>
                          <a:ext uri="{FF2B5EF4-FFF2-40B4-BE49-F238E27FC236}">
                            <a16:creationId xmlns:a16="http://schemas.microsoft.com/office/drawing/2014/main" xmlns="" id="{6C00C178-5AA7-4164-9B54-00F673622772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33315" y="3851427"/>
                        <a:ext cx="2405817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>
                        <a:defPPr>
                          <a:defRPr lang="en-US"/>
                        </a:defPPr>
                        <a:lvl1pPr marL="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r"/>
                        <a:r>
                          <a:rPr lang="en-US" altLang="zh-CN" sz="8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positive regulation of neuron apoptotic process</a:t>
                        </a:r>
                        <a:endParaRPr lang="zh-CN" alt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379" name="文本框 35">
                        <a:extLst>
                          <a:ext uri="{FF2B5EF4-FFF2-40B4-BE49-F238E27FC236}">
                            <a16:creationId xmlns:a16="http://schemas.microsoft.com/office/drawing/2014/main" xmlns="" id="{F2D7717C-B584-4D0E-9415-AD96C4724E95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33315" y="3958076"/>
                        <a:ext cx="2405817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>
                        <a:defPPr>
                          <a:defRPr lang="en-US"/>
                        </a:defPPr>
                        <a:lvl1pPr marL="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1pPr>
                        <a:lvl2pPr marL="4572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2pPr>
                        <a:lvl3pPr marL="9144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3pPr>
                        <a:lvl4pPr marL="13716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4pPr>
                        <a:lvl5pPr marL="18288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5pPr>
                        <a:lvl6pPr marL="22860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6pPr>
                        <a:lvl7pPr marL="27432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7pPr>
                        <a:lvl8pPr marL="32004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8pPr>
                        <a:lvl9pPr marL="3657600" algn="l" defTabSz="457200" rtl="0" eaLnBrk="1" latinLnBrk="0" hangingPunct="1">
                          <a:defRPr sz="1800" kern="1200">
                            <a:solidFill>
                              <a:schemeClr val="tx1"/>
                            </a:solidFill>
                            <a:latin typeface="+mn-lt"/>
                            <a:ea typeface="+mn-ea"/>
                            <a:cs typeface="+mn-cs"/>
                          </a:defRPr>
                        </a:lvl9pPr>
                      </a:lstStyle>
                      <a:p>
                        <a:pPr algn="r"/>
                        <a:r>
                          <a:rPr lang="en-US" altLang="zh-CN" sz="8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neutrophil chemotaxis</a:t>
                        </a:r>
                        <a:endParaRPr lang="zh-CN" alt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</p:grpSp>
              </p:grpSp>
            </p:grpSp>
            <p:sp>
              <p:nvSpPr>
                <p:cNvPr id="327" name="文本框 326">
                  <a:extLst>
                    <a:ext uri="{FF2B5EF4-FFF2-40B4-BE49-F238E27FC236}">
                      <a16:creationId xmlns:a16="http://schemas.microsoft.com/office/drawing/2014/main" xmlns="" id="{AFB7BC1C-156A-4BA6-9959-3F6E78A17E0C}"/>
                    </a:ext>
                  </a:extLst>
                </p:cNvPr>
                <p:cNvSpPr txBox="1"/>
                <p:nvPr/>
              </p:nvSpPr>
              <p:spPr>
                <a:xfrm>
                  <a:off x="3182517" y="4242947"/>
                  <a:ext cx="96709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nrichment score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328" name="组合 327">
                  <a:extLst>
                    <a:ext uri="{FF2B5EF4-FFF2-40B4-BE49-F238E27FC236}">
                      <a16:creationId xmlns:a16="http://schemas.microsoft.com/office/drawing/2014/main" xmlns="" id="{1E513966-5C08-4319-BF6A-10C74C778FC3}"/>
                    </a:ext>
                  </a:extLst>
                </p:cNvPr>
                <p:cNvGrpSpPr/>
                <p:nvPr/>
              </p:nvGrpSpPr>
              <p:grpSpPr>
                <a:xfrm>
                  <a:off x="4620699" y="663946"/>
                  <a:ext cx="1335819" cy="3615346"/>
                  <a:chOff x="4620699" y="663946"/>
                  <a:chExt cx="1335819" cy="3615346"/>
                </a:xfrm>
              </p:grpSpPr>
              <p:grpSp>
                <p:nvGrpSpPr>
                  <p:cNvPr id="329" name="组合 328">
                    <a:extLst>
                      <a:ext uri="{FF2B5EF4-FFF2-40B4-BE49-F238E27FC236}">
                        <a16:creationId xmlns:a16="http://schemas.microsoft.com/office/drawing/2014/main" xmlns="" id="{9A321A1A-10BA-4BB7-99D1-C4E8874AA22F}"/>
                      </a:ext>
                    </a:extLst>
                  </p:cNvPr>
                  <p:cNvGrpSpPr/>
                  <p:nvPr/>
                </p:nvGrpSpPr>
                <p:grpSpPr>
                  <a:xfrm>
                    <a:off x="4620699" y="663946"/>
                    <a:ext cx="724061" cy="1489744"/>
                    <a:chOff x="4620699" y="663946"/>
                    <a:chExt cx="724061" cy="1489744"/>
                  </a:xfrm>
                </p:grpSpPr>
                <p:pic>
                  <p:nvPicPr>
                    <p:cNvPr id="351" name="图片 350">
                      <a:extLst>
                        <a:ext uri="{FF2B5EF4-FFF2-40B4-BE49-F238E27FC236}">
                          <a16:creationId xmlns:a16="http://schemas.microsoft.com/office/drawing/2014/main" xmlns="" id="{D71801B6-A7EC-4EF5-A871-70EA364F51D2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3"/>
                    <a:stretch>
                      <a:fillRect/>
                    </a:stretch>
                  </p:blipFill>
                  <p:spPr>
                    <a:xfrm>
                      <a:off x="4706384" y="820121"/>
                      <a:ext cx="298465" cy="1333569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352" name="文本框 351">
                      <a:extLst>
                        <a:ext uri="{FF2B5EF4-FFF2-40B4-BE49-F238E27FC236}">
                          <a16:creationId xmlns:a16="http://schemas.microsoft.com/office/drawing/2014/main" xmlns="" id="{C13C5EE4-65A4-460A-97BC-2CE74B68E8A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620699" y="663946"/>
                      <a:ext cx="533562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zh-CN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grpSp>
                  <p:nvGrpSpPr>
                    <p:cNvPr id="353" name="组合 352">
                      <a:extLst>
                        <a:ext uri="{FF2B5EF4-FFF2-40B4-BE49-F238E27FC236}">
                          <a16:creationId xmlns:a16="http://schemas.microsoft.com/office/drawing/2014/main" xmlns="" id="{A4B673C2-D7CC-44F2-BC92-6D3723530A8C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4897844" y="945022"/>
                      <a:ext cx="446916" cy="1060539"/>
                      <a:chOff x="4897844" y="945022"/>
                      <a:chExt cx="446916" cy="1060539"/>
                    </a:xfrm>
                  </p:grpSpPr>
                  <p:sp>
                    <p:nvSpPr>
                      <p:cNvPr id="354" name="文本框 353">
                        <a:extLst>
                          <a:ext uri="{FF2B5EF4-FFF2-40B4-BE49-F238E27FC236}">
                            <a16:creationId xmlns:a16="http://schemas.microsoft.com/office/drawing/2014/main" xmlns="" id="{0DF3106A-465B-40C7-9DEF-A4238A0C546F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897844" y="945022"/>
                        <a:ext cx="446916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zh-CN" sz="8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0.008</a:t>
                        </a:r>
                        <a:endParaRPr lang="zh-CN" alt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355" name="文本框 354">
                        <a:extLst>
                          <a:ext uri="{FF2B5EF4-FFF2-40B4-BE49-F238E27FC236}">
                            <a16:creationId xmlns:a16="http://schemas.microsoft.com/office/drawing/2014/main" xmlns="" id="{8CF09FC6-201F-4153-9120-9AEDDD57808B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897844" y="1226720"/>
                        <a:ext cx="446916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zh-CN" sz="8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0.006</a:t>
                        </a:r>
                        <a:endParaRPr lang="zh-CN" alt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356" name="文本框 355">
                        <a:extLst>
                          <a:ext uri="{FF2B5EF4-FFF2-40B4-BE49-F238E27FC236}">
                            <a16:creationId xmlns:a16="http://schemas.microsoft.com/office/drawing/2014/main" xmlns="" id="{66A6F5E6-F1F4-434C-A2BD-8F28C4EB1C5B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897844" y="1508418"/>
                        <a:ext cx="446916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zh-CN" sz="8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0.004</a:t>
                        </a:r>
                        <a:endParaRPr lang="zh-CN" alt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357" name="文本框 356">
                        <a:extLst>
                          <a:ext uri="{FF2B5EF4-FFF2-40B4-BE49-F238E27FC236}">
                            <a16:creationId xmlns:a16="http://schemas.microsoft.com/office/drawing/2014/main" xmlns="" id="{75B90443-7DC8-435E-AD22-908541363499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897844" y="1790117"/>
                        <a:ext cx="446916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zh-CN" sz="8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0.002</a:t>
                        </a:r>
                        <a:endParaRPr lang="zh-CN" alt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</p:grpSp>
              </p:grpSp>
              <p:grpSp>
                <p:nvGrpSpPr>
                  <p:cNvPr id="330" name="组合 329">
                    <a:extLst>
                      <a:ext uri="{FF2B5EF4-FFF2-40B4-BE49-F238E27FC236}">
                        <a16:creationId xmlns:a16="http://schemas.microsoft.com/office/drawing/2014/main" xmlns="" id="{3E189B14-A057-44C4-8231-7F0E06372D73}"/>
                      </a:ext>
                    </a:extLst>
                  </p:cNvPr>
                  <p:cNvGrpSpPr/>
                  <p:nvPr/>
                </p:nvGrpSpPr>
                <p:grpSpPr>
                  <a:xfrm>
                    <a:off x="4636067" y="2172909"/>
                    <a:ext cx="637182" cy="999788"/>
                    <a:chOff x="4636067" y="2172909"/>
                    <a:chExt cx="637182" cy="999788"/>
                  </a:xfrm>
                </p:grpSpPr>
                <p:sp>
                  <p:nvSpPr>
                    <p:cNvPr id="341" name="文本框 340">
                      <a:extLst>
                        <a:ext uri="{FF2B5EF4-FFF2-40B4-BE49-F238E27FC236}">
                          <a16:creationId xmlns:a16="http://schemas.microsoft.com/office/drawing/2014/main" xmlns="" id="{084F532C-D2F0-410C-84DC-7CF4EA68A77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636067" y="2172909"/>
                      <a:ext cx="533562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istHit</a:t>
                      </a:r>
                      <a:endParaRPr lang="zh-CN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grpSp>
                  <p:nvGrpSpPr>
                    <p:cNvPr id="342" name="组合 341">
                      <a:extLst>
                        <a:ext uri="{FF2B5EF4-FFF2-40B4-BE49-F238E27FC236}">
                          <a16:creationId xmlns:a16="http://schemas.microsoft.com/office/drawing/2014/main" xmlns="" id="{2E6A210D-9B35-471C-9126-0B2CE2B8B201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4767604" y="2384670"/>
                      <a:ext cx="505645" cy="788027"/>
                      <a:chOff x="4767604" y="2346570"/>
                      <a:chExt cx="505645" cy="788027"/>
                    </a:xfrm>
                  </p:grpSpPr>
                  <p:grpSp>
                    <p:nvGrpSpPr>
                      <p:cNvPr id="343" name="组合 342">
                        <a:extLst>
                          <a:ext uri="{FF2B5EF4-FFF2-40B4-BE49-F238E27FC236}">
                            <a16:creationId xmlns:a16="http://schemas.microsoft.com/office/drawing/2014/main" xmlns="" id="{CF091108-63FE-4758-AFF3-208ABD817B86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4826333" y="2346570"/>
                        <a:ext cx="446916" cy="788027"/>
                        <a:chOff x="4826333" y="2346570"/>
                        <a:chExt cx="446916" cy="788027"/>
                      </a:xfrm>
                    </p:grpSpPr>
                    <p:sp>
                      <p:nvSpPr>
                        <p:cNvPr id="348" name="文本框 347">
                          <a:extLst>
                            <a:ext uri="{FF2B5EF4-FFF2-40B4-BE49-F238E27FC236}">
                              <a16:creationId xmlns:a16="http://schemas.microsoft.com/office/drawing/2014/main" xmlns="" id="{07EA23DD-AF55-4EE7-B211-3F3250104DF1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4826333" y="2346570"/>
                          <a:ext cx="446916" cy="21544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altLang="zh-CN" sz="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1</a:t>
                          </a:r>
                          <a:endParaRPr lang="zh-CN" altLang="en-US" sz="8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349" name="文本框 348">
                          <a:extLst>
                            <a:ext uri="{FF2B5EF4-FFF2-40B4-BE49-F238E27FC236}">
                              <a16:creationId xmlns:a16="http://schemas.microsoft.com/office/drawing/2014/main" xmlns="" id="{A5658D13-8AD1-41C8-82A2-7C1969C94EEB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4826333" y="2601630"/>
                          <a:ext cx="446916" cy="21544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altLang="zh-CN" sz="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2</a:t>
                          </a:r>
                          <a:endParaRPr lang="zh-CN" altLang="en-US" sz="8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350" name="文本框 349">
                          <a:extLst>
                            <a:ext uri="{FF2B5EF4-FFF2-40B4-BE49-F238E27FC236}">
                              <a16:creationId xmlns:a16="http://schemas.microsoft.com/office/drawing/2014/main" xmlns="" id="{2ACF72AD-4598-479F-B544-2CE2F0DA62BE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4826333" y="2919153"/>
                          <a:ext cx="446916" cy="21544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altLang="zh-CN" sz="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3</a:t>
                          </a:r>
                          <a:endParaRPr lang="zh-CN" altLang="en-US" sz="8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p:txBody>
                    </p:sp>
                  </p:grpSp>
                  <p:grpSp>
                    <p:nvGrpSpPr>
                      <p:cNvPr id="344" name="组合 343">
                        <a:extLst>
                          <a:ext uri="{FF2B5EF4-FFF2-40B4-BE49-F238E27FC236}">
                            <a16:creationId xmlns:a16="http://schemas.microsoft.com/office/drawing/2014/main" xmlns="" id="{1FC2813A-3291-4256-A193-56C00F3F5B4B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4767604" y="2359751"/>
                        <a:ext cx="213838" cy="753371"/>
                        <a:chOff x="4767604" y="2359751"/>
                        <a:chExt cx="213838" cy="753371"/>
                      </a:xfrm>
                    </p:grpSpPr>
                    <p:pic>
                      <p:nvPicPr>
                        <p:cNvPr id="345" name="图片 344">
                          <a:extLst>
                            <a:ext uri="{FF2B5EF4-FFF2-40B4-BE49-F238E27FC236}">
                              <a16:creationId xmlns:a16="http://schemas.microsoft.com/office/drawing/2014/main" xmlns="" id="{2B2BCF3C-D9F9-4E2A-993B-A285B0B76EF3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4767604" y="2359751"/>
                          <a:ext cx="209561" cy="190510"/>
                        </a:xfrm>
                        <a:prstGeom prst="rect">
                          <a:avLst/>
                        </a:prstGeom>
                      </p:spPr>
                    </p:pic>
                    <p:pic>
                      <p:nvPicPr>
                        <p:cNvPr id="346" name="图片 345">
                          <a:extLst>
                            <a:ext uri="{FF2B5EF4-FFF2-40B4-BE49-F238E27FC236}">
                              <a16:creationId xmlns:a16="http://schemas.microsoft.com/office/drawing/2014/main" xmlns="" id="{28AC328C-BA9A-4D54-8BF3-E50AE89C0E85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4780304" y="2624672"/>
                          <a:ext cx="184159" cy="177809"/>
                        </a:xfrm>
                        <a:prstGeom prst="rect">
                          <a:avLst/>
                        </a:prstGeom>
                      </p:spPr>
                    </p:pic>
                    <p:pic>
                      <p:nvPicPr>
                        <p:cNvPr id="347" name="图片 346">
                          <a:extLst>
                            <a:ext uri="{FF2B5EF4-FFF2-40B4-BE49-F238E27FC236}">
                              <a16:creationId xmlns:a16="http://schemas.microsoft.com/office/drawing/2014/main" xmlns="" id="{8FAFDAFC-C9CA-4DFB-8724-4EBE6FCAE170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6"/>
                        <a:srcRect l="24999" t="1" r="1" b="19131"/>
                        <a:stretch/>
                      </p:blipFill>
                      <p:spPr>
                        <a:xfrm>
                          <a:off x="4771881" y="2876891"/>
                          <a:ext cx="209561" cy="236231"/>
                        </a:xfrm>
                        <a:prstGeom prst="rect">
                          <a:avLst/>
                        </a:prstGeom>
                      </p:spPr>
                    </p:pic>
                  </p:grpSp>
                </p:grpSp>
              </p:grpSp>
              <p:grpSp>
                <p:nvGrpSpPr>
                  <p:cNvPr id="331" name="组合 330">
                    <a:extLst>
                      <a:ext uri="{FF2B5EF4-FFF2-40B4-BE49-F238E27FC236}">
                        <a16:creationId xmlns:a16="http://schemas.microsoft.com/office/drawing/2014/main" xmlns="" id="{5E28AB6A-8EE9-43EA-A8F3-01CB5FC6E389}"/>
                      </a:ext>
                    </a:extLst>
                  </p:cNvPr>
                  <p:cNvGrpSpPr/>
                  <p:nvPr/>
                </p:nvGrpSpPr>
                <p:grpSpPr>
                  <a:xfrm>
                    <a:off x="4636067" y="3202872"/>
                    <a:ext cx="1320451" cy="1076420"/>
                    <a:chOff x="4636067" y="3202872"/>
                    <a:chExt cx="1320451" cy="1076420"/>
                  </a:xfrm>
                </p:grpSpPr>
                <p:sp>
                  <p:nvSpPr>
                    <p:cNvPr id="332" name="文本框 331">
                      <a:extLst>
                        <a:ext uri="{FF2B5EF4-FFF2-40B4-BE49-F238E27FC236}">
                          <a16:creationId xmlns:a16="http://schemas.microsoft.com/office/drawing/2014/main" xmlns="" id="{30DD5210-1F8A-499A-BFDE-2B5BCE2F84B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636067" y="3202872"/>
                      <a:ext cx="637182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tegory</a:t>
                      </a:r>
                      <a:endParaRPr lang="zh-CN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grpSp>
                  <p:nvGrpSpPr>
                    <p:cNvPr id="333" name="组合 332">
                      <a:extLst>
                        <a:ext uri="{FF2B5EF4-FFF2-40B4-BE49-F238E27FC236}">
                          <a16:creationId xmlns:a16="http://schemas.microsoft.com/office/drawing/2014/main" xmlns="" id="{499A74A8-D7E4-4A7D-A0D5-B1CFA92D8C6A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4696241" y="3437535"/>
                      <a:ext cx="364204" cy="841757"/>
                      <a:chOff x="4696241" y="3437535"/>
                      <a:chExt cx="364204" cy="841757"/>
                    </a:xfrm>
                  </p:grpSpPr>
                  <p:pic>
                    <p:nvPicPr>
                      <p:cNvPr id="338" name="图片 337">
                        <a:extLst>
                          <a:ext uri="{FF2B5EF4-FFF2-40B4-BE49-F238E27FC236}">
                            <a16:creationId xmlns:a16="http://schemas.microsoft.com/office/drawing/2014/main" xmlns="" id="{9280E668-0F2D-4621-90E6-974A7C8966C8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7"/>
                      <a:srcRect l="1" r="-15308" b="82262"/>
                      <a:stretch/>
                    </p:blipFill>
                    <p:spPr>
                      <a:xfrm>
                        <a:off x="4696241" y="3437535"/>
                        <a:ext cx="344150" cy="197118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339" name="图片 338">
                        <a:extLst>
                          <a:ext uri="{FF2B5EF4-FFF2-40B4-BE49-F238E27FC236}">
                            <a16:creationId xmlns:a16="http://schemas.microsoft.com/office/drawing/2014/main" xmlns="" id="{CB848F5A-2074-4C2C-9416-0DFDC352CB56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7"/>
                      <a:srcRect t="83250"/>
                      <a:stretch/>
                    </p:blipFill>
                    <p:spPr>
                      <a:xfrm>
                        <a:off x="4696241" y="4093147"/>
                        <a:ext cx="298465" cy="186145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340" name="图片 339">
                        <a:extLst>
                          <a:ext uri="{FF2B5EF4-FFF2-40B4-BE49-F238E27FC236}">
                            <a16:creationId xmlns:a16="http://schemas.microsoft.com/office/drawing/2014/main" xmlns="" id="{320DACBF-081A-4197-8916-E74275A02763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7"/>
                      <a:srcRect t="42177" r="-22026" b="40085"/>
                      <a:stretch/>
                    </p:blipFill>
                    <p:spPr>
                      <a:xfrm>
                        <a:off x="4696241" y="3765341"/>
                        <a:ext cx="364204" cy="197118"/>
                      </a:xfrm>
                      <a:prstGeom prst="rect">
                        <a:avLst/>
                      </a:prstGeom>
                    </p:spPr>
                  </p:pic>
                </p:grpSp>
                <p:grpSp>
                  <p:nvGrpSpPr>
                    <p:cNvPr id="334" name="组合 333">
                      <a:extLst>
                        <a:ext uri="{FF2B5EF4-FFF2-40B4-BE49-F238E27FC236}">
                          <a16:creationId xmlns:a16="http://schemas.microsoft.com/office/drawing/2014/main" xmlns="" id="{63BF2CD4-2F2B-4434-9BCE-78CC607F5EA2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4855616" y="3450816"/>
                      <a:ext cx="1100902" cy="820769"/>
                      <a:chOff x="4855616" y="3450816"/>
                      <a:chExt cx="1100902" cy="820769"/>
                    </a:xfrm>
                  </p:grpSpPr>
                  <p:sp>
                    <p:nvSpPr>
                      <p:cNvPr id="335" name="文本框 334">
                        <a:extLst>
                          <a:ext uri="{FF2B5EF4-FFF2-40B4-BE49-F238E27FC236}">
                            <a16:creationId xmlns:a16="http://schemas.microsoft.com/office/drawing/2014/main" xmlns="" id="{3076BC74-A570-4218-AEDE-256CBAEE76D9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855616" y="3450816"/>
                        <a:ext cx="1097085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zh-CN" sz="8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molecular function</a:t>
                        </a:r>
                        <a:endParaRPr lang="zh-CN" alt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336" name="文本框 335">
                        <a:extLst>
                          <a:ext uri="{FF2B5EF4-FFF2-40B4-BE49-F238E27FC236}">
                            <a16:creationId xmlns:a16="http://schemas.microsoft.com/office/drawing/2014/main" xmlns="" id="{33A72BD2-4E6E-4820-97C8-E5B9199B48C3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855616" y="3753478"/>
                        <a:ext cx="1097085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zh-CN" sz="8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biological process</a:t>
                        </a:r>
                        <a:endParaRPr lang="zh-CN" alt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  <p:sp>
                    <p:nvSpPr>
                      <p:cNvPr id="337" name="文本框 336">
                        <a:extLst>
                          <a:ext uri="{FF2B5EF4-FFF2-40B4-BE49-F238E27FC236}">
                            <a16:creationId xmlns:a16="http://schemas.microsoft.com/office/drawing/2014/main" xmlns="" id="{9F614920-C170-4ECB-804B-C4E05A10727D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855616" y="4056141"/>
                        <a:ext cx="1100902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zh-CN" sz="8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cellular component</a:t>
                        </a:r>
                        <a:endParaRPr lang="zh-CN" altLang="en-US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endParaRPr>
                      </a:p>
                    </p:txBody>
                  </p:sp>
                </p:grpSp>
              </p:grpSp>
            </p:grpSp>
          </p:grpSp>
        </p:grpSp>
      </p:grpSp>
    </p:spTree>
    <p:extLst>
      <p:ext uri="{BB962C8B-B14F-4D97-AF65-F5344CB8AC3E}">
        <p14:creationId xmlns:p14="http://schemas.microsoft.com/office/powerpoint/2010/main" xmlns="" val="31923260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53</Words>
  <Application>Microsoft Office PowerPoint</Application>
  <PresentationFormat>A4 Paper (210x297 mm)</PresentationFormat>
  <Paragraphs>4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主题​​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图图</dc:creator>
  <cp:lastModifiedBy>User</cp:lastModifiedBy>
  <cp:revision>2</cp:revision>
  <dcterms:created xsi:type="dcterms:W3CDTF">2021-12-15T09:27:30Z</dcterms:created>
  <dcterms:modified xsi:type="dcterms:W3CDTF">2022-03-27T09:56:01Z</dcterms:modified>
</cp:coreProperties>
</file>